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335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173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71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505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907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799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58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41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74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51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364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A427F-8980-4F77-AD43-7086C963B567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FC97C-344F-4393-9FA8-635BAA32E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81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4952188"/>
              </p:ext>
            </p:extLst>
          </p:nvPr>
        </p:nvGraphicFramePr>
        <p:xfrm>
          <a:off x="572653" y="581891"/>
          <a:ext cx="10538691" cy="586834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70183">
                  <a:extLst>
                    <a:ext uri="{9D8B030D-6E8A-4147-A177-3AD203B41FA5}">
                      <a16:colId xmlns:a16="http://schemas.microsoft.com/office/drawing/2014/main" xmlns="" val="2148755691"/>
                    </a:ext>
                  </a:extLst>
                </a:gridCol>
                <a:gridCol w="1433803">
                  <a:extLst>
                    <a:ext uri="{9D8B030D-6E8A-4147-A177-3AD203B41FA5}">
                      <a16:colId xmlns:a16="http://schemas.microsoft.com/office/drawing/2014/main" xmlns="" val="3338034878"/>
                    </a:ext>
                  </a:extLst>
                </a:gridCol>
                <a:gridCol w="1501993">
                  <a:extLst>
                    <a:ext uri="{9D8B030D-6E8A-4147-A177-3AD203B41FA5}">
                      <a16:colId xmlns:a16="http://schemas.microsoft.com/office/drawing/2014/main" xmlns="" val="3050811337"/>
                    </a:ext>
                  </a:extLst>
                </a:gridCol>
                <a:gridCol w="1514363">
                  <a:extLst>
                    <a:ext uri="{9D8B030D-6E8A-4147-A177-3AD203B41FA5}">
                      <a16:colId xmlns:a16="http://schemas.microsoft.com/office/drawing/2014/main" xmlns="" val="991624277"/>
                    </a:ext>
                  </a:extLst>
                </a:gridCol>
                <a:gridCol w="1501993">
                  <a:extLst>
                    <a:ext uri="{9D8B030D-6E8A-4147-A177-3AD203B41FA5}">
                      <a16:colId xmlns:a16="http://schemas.microsoft.com/office/drawing/2014/main" xmlns="" val="1013321962"/>
                    </a:ext>
                  </a:extLst>
                </a:gridCol>
                <a:gridCol w="1501993">
                  <a:extLst>
                    <a:ext uri="{9D8B030D-6E8A-4147-A177-3AD203B41FA5}">
                      <a16:colId xmlns:a16="http://schemas.microsoft.com/office/drawing/2014/main" xmlns="" val="3060518156"/>
                    </a:ext>
                  </a:extLst>
                </a:gridCol>
                <a:gridCol w="1514363">
                  <a:extLst>
                    <a:ext uri="{9D8B030D-6E8A-4147-A177-3AD203B41FA5}">
                      <a16:colId xmlns:a16="http://schemas.microsoft.com/office/drawing/2014/main" xmlns="" val="977943659"/>
                    </a:ext>
                  </a:extLst>
                </a:gridCol>
              </a:tblGrid>
              <a:tr h="50215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b="0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orani</a:t>
                      </a:r>
                      <a:r>
                        <a:rPr lang="en-US" sz="1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 data</a:t>
                      </a:r>
                      <a:endParaRPr lang="en-US" sz="1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S 12 month data</a:t>
                      </a:r>
                      <a:endParaRPr lang="en-US" sz="1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235426515"/>
                  </a:ext>
                </a:extLst>
              </a:tr>
              <a:tr h="105721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subjects (n=3978) (&gt;18yr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20 </a:t>
                      </a:r>
                      <a:r>
                        <a:rPr lang="en-US" sz="16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sz="16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803</a:t>
                      </a: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-45 </a:t>
                      </a:r>
                      <a:r>
                        <a:rPr lang="en-US" sz="16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2458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subjects (n=39) (&gt;18 </a:t>
                      </a:r>
                      <a:r>
                        <a:rPr lang="en-US" sz="16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=20 yr (18-20 yr) (n=7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-45 yr (n=31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18919116"/>
                  </a:ext>
                </a:extLst>
              </a:tr>
              <a:tr h="65650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duction </a:t>
                      </a:r>
                      <a:r>
                        <a:rPr lang="en-US" sz="16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ity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6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%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85336874"/>
                  </a:ext>
                </a:extLst>
              </a:tr>
              <a:tr h="123296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ventricular Conduction Delay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53856115"/>
                  </a:ext>
                </a:extLst>
              </a:tr>
              <a:tr h="1057219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Bundle Branch Block (RBBB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09421356"/>
                  </a:ext>
                </a:extLst>
              </a:tr>
              <a:tr h="136229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mplete Right Bundle Branch Block (IRBBB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446882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4045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16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YhamDawn</cp:lastModifiedBy>
  <cp:revision>4</cp:revision>
  <dcterms:created xsi:type="dcterms:W3CDTF">2020-02-08T22:46:59Z</dcterms:created>
  <dcterms:modified xsi:type="dcterms:W3CDTF">2020-07-09T02:13:09Z</dcterms:modified>
</cp:coreProperties>
</file>